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54" r:id="rId2"/>
    <p:sldId id="353" r:id="rId3"/>
    <p:sldId id="356" r:id="rId4"/>
    <p:sldId id="360" r:id="rId5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75" userDrawn="1">
          <p15:clr>
            <a:srgbClr val="A4A3A4"/>
          </p15:clr>
        </p15:guide>
        <p15:guide id="2" pos="132" userDrawn="1">
          <p15:clr>
            <a:srgbClr val="A4A3A4"/>
          </p15:clr>
        </p15:guide>
        <p15:guide id="3" pos="244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557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96" y="540"/>
      </p:cViewPr>
      <p:guideLst>
        <p:guide orient="horz" pos="1075"/>
        <p:guide pos="132"/>
        <p:guide pos="244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鈴木 裕太" userId="5f87c7e0ca032b78" providerId="LiveId" clId="{887096AD-A0F5-4887-859D-03CED5C4769A}"/>
    <pc:docChg chg="custSel modSld">
      <pc:chgData name="鈴木 裕太" userId="5f87c7e0ca032b78" providerId="LiveId" clId="{887096AD-A0F5-4887-859D-03CED5C4769A}" dt="2023-07-22T00:51:01.909" v="11" actId="1076"/>
      <pc:docMkLst>
        <pc:docMk/>
      </pc:docMkLst>
      <pc:sldChg chg="addSp delSp modSp mod">
        <pc:chgData name="鈴木 裕太" userId="5f87c7e0ca032b78" providerId="LiveId" clId="{887096AD-A0F5-4887-859D-03CED5C4769A}" dt="2023-07-22T00:50:18.325" v="5" actId="1076"/>
        <pc:sldMkLst>
          <pc:docMk/>
          <pc:sldMk cId="2645924326" sldId="356"/>
        </pc:sldMkLst>
        <pc:picChg chg="del">
          <ac:chgData name="鈴木 裕太" userId="5f87c7e0ca032b78" providerId="LiveId" clId="{887096AD-A0F5-4887-859D-03CED5C4769A}" dt="2023-07-22T00:49:56.531" v="0" actId="478"/>
          <ac:picMkLst>
            <pc:docMk/>
            <pc:sldMk cId="2645924326" sldId="356"/>
            <ac:picMk id="6" creationId="{6A5B269E-EDB4-8708-2EFE-534EE740EAF5}"/>
          </ac:picMkLst>
        </pc:picChg>
        <pc:picChg chg="add mod ord">
          <ac:chgData name="鈴木 裕太" userId="5f87c7e0ca032b78" providerId="LiveId" clId="{887096AD-A0F5-4887-859D-03CED5C4769A}" dt="2023-07-22T00:50:18.325" v="5" actId="1076"/>
          <ac:picMkLst>
            <pc:docMk/>
            <pc:sldMk cId="2645924326" sldId="356"/>
            <ac:picMk id="8" creationId="{0458B241-367B-43FC-121E-0A80291871C1}"/>
          </ac:picMkLst>
        </pc:picChg>
      </pc:sldChg>
      <pc:sldChg chg="addSp delSp modSp mod">
        <pc:chgData name="鈴木 裕太" userId="5f87c7e0ca032b78" providerId="LiveId" clId="{887096AD-A0F5-4887-859D-03CED5C4769A}" dt="2023-07-22T00:51:01.909" v="11" actId="1076"/>
        <pc:sldMkLst>
          <pc:docMk/>
          <pc:sldMk cId="1989639512" sldId="360"/>
        </pc:sldMkLst>
        <pc:picChg chg="add mod ord">
          <ac:chgData name="鈴木 裕太" userId="5f87c7e0ca032b78" providerId="LiveId" clId="{887096AD-A0F5-4887-859D-03CED5C4769A}" dt="2023-07-22T00:51:01.909" v="11" actId="1076"/>
          <ac:picMkLst>
            <pc:docMk/>
            <pc:sldMk cId="1989639512" sldId="360"/>
            <ac:picMk id="6" creationId="{69DC1941-1D3F-800A-8972-E715C3A0842D}"/>
          </ac:picMkLst>
        </pc:picChg>
        <pc:picChg chg="del">
          <ac:chgData name="鈴木 裕太" userId="5f87c7e0ca032b78" providerId="LiveId" clId="{887096AD-A0F5-4887-859D-03CED5C4769A}" dt="2023-07-22T00:50:40.201" v="6" actId="478"/>
          <ac:picMkLst>
            <pc:docMk/>
            <pc:sldMk cId="1989639512" sldId="360"/>
            <ac:picMk id="8" creationId="{8A74D464-8CC6-537D-B904-73A5A4D2FFDC}"/>
          </ac:picMkLst>
        </pc:picChg>
      </pc:sldChg>
    </pc:docChg>
  </pc:docChgLst>
  <pc:docChgLst>
    <pc:chgData name="鈴木 裕太" userId="5f87c7e0ca032b78" providerId="LiveId" clId="{8119A30B-2635-438E-A7B7-4E8971B269F0}"/>
    <pc:docChg chg="delSld">
      <pc:chgData name="鈴木 裕太" userId="5f87c7e0ca032b78" providerId="LiveId" clId="{8119A30B-2635-438E-A7B7-4E8971B269F0}" dt="2023-04-06T14:06:20.527" v="9" actId="47"/>
      <pc:docMkLst>
        <pc:docMk/>
      </pc:docMkLst>
      <pc:sldChg chg="del">
        <pc:chgData name="鈴木 裕太" userId="5f87c7e0ca032b78" providerId="LiveId" clId="{8119A30B-2635-438E-A7B7-4E8971B269F0}" dt="2023-04-06T14:06:16.785" v="0" actId="47"/>
        <pc:sldMkLst>
          <pc:docMk/>
          <pc:sldMk cId="1300025614" sldId="285"/>
        </pc:sldMkLst>
      </pc:sldChg>
      <pc:sldChg chg="del">
        <pc:chgData name="鈴木 裕太" userId="5f87c7e0ca032b78" providerId="LiveId" clId="{8119A30B-2635-438E-A7B7-4E8971B269F0}" dt="2023-04-06T14:06:18.100" v="4" actId="47"/>
        <pc:sldMkLst>
          <pc:docMk/>
          <pc:sldMk cId="562405105" sldId="312"/>
        </pc:sldMkLst>
      </pc:sldChg>
      <pc:sldChg chg="del">
        <pc:chgData name="鈴木 裕太" userId="5f87c7e0ca032b78" providerId="LiveId" clId="{8119A30B-2635-438E-A7B7-4E8971B269F0}" dt="2023-04-06T14:06:17.317" v="1" actId="47"/>
        <pc:sldMkLst>
          <pc:docMk/>
          <pc:sldMk cId="3403972902" sldId="316"/>
        </pc:sldMkLst>
      </pc:sldChg>
      <pc:sldChg chg="del">
        <pc:chgData name="鈴木 裕太" userId="5f87c7e0ca032b78" providerId="LiveId" clId="{8119A30B-2635-438E-A7B7-4E8971B269F0}" dt="2023-04-06T14:06:17.660" v="2" actId="47"/>
        <pc:sldMkLst>
          <pc:docMk/>
          <pc:sldMk cId="152802557" sldId="317"/>
        </pc:sldMkLst>
      </pc:sldChg>
      <pc:sldChg chg="del">
        <pc:chgData name="鈴木 裕太" userId="5f87c7e0ca032b78" providerId="LiveId" clId="{8119A30B-2635-438E-A7B7-4E8971B269F0}" dt="2023-04-06T14:06:17.896" v="3" actId="47"/>
        <pc:sldMkLst>
          <pc:docMk/>
          <pc:sldMk cId="2799665734" sldId="318"/>
        </pc:sldMkLst>
      </pc:sldChg>
      <pc:sldChg chg="del">
        <pc:chgData name="鈴木 裕太" userId="5f87c7e0ca032b78" providerId="LiveId" clId="{8119A30B-2635-438E-A7B7-4E8971B269F0}" dt="2023-04-06T14:06:18.302" v="5" actId="47"/>
        <pc:sldMkLst>
          <pc:docMk/>
          <pc:sldMk cId="892744918" sldId="319"/>
        </pc:sldMkLst>
      </pc:sldChg>
      <pc:sldChg chg="del">
        <pc:chgData name="鈴木 裕太" userId="5f87c7e0ca032b78" providerId="LiveId" clId="{8119A30B-2635-438E-A7B7-4E8971B269F0}" dt="2023-04-06T14:06:18.518" v="6" actId="47"/>
        <pc:sldMkLst>
          <pc:docMk/>
          <pc:sldMk cId="3852035896" sldId="320"/>
        </pc:sldMkLst>
      </pc:sldChg>
      <pc:sldChg chg="del">
        <pc:chgData name="鈴木 裕太" userId="5f87c7e0ca032b78" providerId="LiveId" clId="{8119A30B-2635-438E-A7B7-4E8971B269F0}" dt="2023-04-06T14:06:19.901" v="8" actId="47"/>
        <pc:sldMkLst>
          <pc:docMk/>
          <pc:sldMk cId="3264097041" sldId="325"/>
        </pc:sldMkLst>
      </pc:sldChg>
      <pc:sldChg chg="del">
        <pc:chgData name="鈴木 裕太" userId="5f87c7e0ca032b78" providerId="LiveId" clId="{8119A30B-2635-438E-A7B7-4E8971B269F0}" dt="2023-04-06T14:06:19.248" v="7" actId="47"/>
        <pc:sldMkLst>
          <pc:docMk/>
          <pc:sldMk cId="4083904018" sldId="346"/>
        </pc:sldMkLst>
      </pc:sldChg>
      <pc:sldChg chg="del">
        <pc:chgData name="鈴木 裕太" userId="5f87c7e0ca032b78" providerId="LiveId" clId="{8119A30B-2635-438E-A7B7-4E8971B269F0}" dt="2023-04-06T14:06:20.527" v="9" actId="47"/>
        <pc:sldMkLst>
          <pc:docMk/>
          <pc:sldMk cId="2947683067" sldId="359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D91A511-7D07-45F5-8ED7-38D792E912C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5867F001-B8AB-4317-9606-528B8FE492C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4038FB3-9E55-420A-8BD2-CA2CD2A686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9CED3E-DBD8-4918-938D-27755D3C3BD0}" type="datetimeFigureOut">
              <a:rPr kumimoji="1" lang="ja-JP" altLang="en-US" smtClean="0"/>
              <a:t>2023/7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A8CF69D-080E-47B6-9908-373024FC36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2A01A18-666A-48A3-9F90-78C8F8004B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98A39-229D-4D69-9BDF-E34593257F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92552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CF0EDC4-6D70-4EA0-8A45-FA386133EC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9525068-17C1-4607-9795-E7B86EF8895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E23CDCB-73A2-4846-8626-1B11D5840E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9CED3E-DBD8-4918-938D-27755D3C3BD0}" type="datetimeFigureOut">
              <a:rPr kumimoji="1" lang="ja-JP" altLang="en-US" smtClean="0"/>
              <a:t>2023/7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1B12B41-F85D-4197-B523-8AC5F3ACA6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5A2C907-8E87-4338-820C-4846639D9F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98A39-229D-4D69-9BDF-E34593257F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03118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1FD388B5-D854-4935-A157-DCE776860F4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FF9525B-1364-4BDA-AA97-1B861FA2130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ADA9479-22E0-47BA-B8F4-C0B9935C0B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9CED3E-DBD8-4918-938D-27755D3C3BD0}" type="datetimeFigureOut">
              <a:rPr kumimoji="1" lang="ja-JP" altLang="en-US" smtClean="0"/>
              <a:t>2023/7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6660C03-07F3-430A-A06F-0A6CE8C3C3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054B844-D8B2-44F0-9C35-288AE96E54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98A39-229D-4D69-9BDF-E34593257F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31160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952633A-16D8-4A35-9D01-F09FA12152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2884F7E-4ED2-464D-9CF0-545A1501A2F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0C30ED2-64A7-41B0-83F0-B8D84D47C7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9CED3E-DBD8-4918-938D-27755D3C3BD0}" type="datetimeFigureOut">
              <a:rPr kumimoji="1" lang="ja-JP" altLang="en-US" smtClean="0"/>
              <a:t>2023/7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067EDEC-F045-46CB-8F61-2E84F0388E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EFF74EF-9E49-431E-88FA-804EFEE280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98A39-229D-4D69-9BDF-E34593257F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72345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ABB965F-D613-42C4-9B39-432CB6940F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CFA1795-0858-42AD-AC23-209A5A269E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58E504B-A821-482E-9D39-9C98E40F01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9CED3E-DBD8-4918-938D-27755D3C3BD0}" type="datetimeFigureOut">
              <a:rPr kumimoji="1" lang="ja-JP" altLang="en-US" smtClean="0"/>
              <a:t>2023/7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DE38546-7B15-4E07-B011-45DC06910D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801A5D7-8BA9-4756-9E6A-C00FB696AF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98A39-229D-4D69-9BDF-E34593257F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85544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28A9847-B9BA-4DB3-9A15-4DA7670518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C056936-20AE-4640-82C0-6CB995532A5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5F6D3AB-E7BA-459A-B6D7-F1D136CFF5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926E9AF-E09F-4EE4-8012-7E4F4C6575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9CED3E-DBD8-4918-938D-27755D3C3BD0}" type="datetimeFigureOut">
              <a:rPr kumimoji="1" lang="ja-JP" altLang="en-US" smtClean="0"/>
              <a:t>2023/7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99E4F9C-751E-41E3-B058-739CED56DE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A183464-00D3-4375-88B2-543C2D954F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98A39-229D-4D69-9BDF-E34593257F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01175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AA770C9-5561-4083-8143-70BFACAB6B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22085D4-9D32-4F9F-90AD-03CFAFAB21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FA6D953-A05A-46E9-8D3C-858208E1CAF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5EEC0FE6-EE21-48E7-8F5A-DCE975756A7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5D4A56A0-8437-4051-B6AB-AD83ED46D76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32B70B63-4493-4409-85CD-181D9530D7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9CED3E-DBD8-4918-938D-27755D3C3BD0}" type="datetimeFigureOut">
              <a:rPr kumimoji="1" lang="ja-JP" altLang="en-US" smtClean="0"/>
              <a:t>2023/7/2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C21C3263-2AE2-492E-B414-01F01A856E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BE16C5AD-4622-4A89-AB0C-05CEF8BD3D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98A39-229D-4D69-9BDF-E34593257F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0629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47BA16C-9EDF-496E-8C32-9B757B452D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BBBE03CD-1D88-4448-91CB-C3AF3FD52D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9CED3E-DBD8-4918-938D-27755D3C3BD0}" type="datetimeFigureOut">
              <a:rPr kumimoji="1" lang="ja-JP" altLang="en-US" smtClean="0"/>
              <a:t>2023/7/2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F7224E92-C72C-4B2C-8437-75E710EBE2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75E5F520-3254-4197-87E1-EC1445CC9B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98A39-229D-4D69-9BDF-E34593257F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62923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102B9FD9-5186-4C9E-A3B8-FFA4B80306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9CED3E-DBD8-4918-938D-27755D3C3BD0}" type="datetimeFigureOut">
              <a:rPr kumimoji="1" lang="ja-JP" altLang="en-US" smtClean="0"/>
              <a:t>2023/7/2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B96B2249-5E67-48F8-8C8D-0671C5AD14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2BD4CF3-F622-4508-975A-2E8B60BCB7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98A39-229D-4D69-9BDF-E34593257F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68884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22F6FF7-0F4B-4D5E-8644-E7E3D5F052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7B38466-380E-4534-BE7A-A3B83B18159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0DFBF56-63D5-4229-8E3D-2B867F9649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1B84DB8-9C85-4178-AC41-FEA8F3FDA6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9CED3E-DBD8-4918-938D-27755D3C3BD0}" type="datetimeFigureOut">
              <a:rPr kumimoji="1" lang="ja-JP" altLang="en-US" smtClean="0"/>
              <a:t>2023/7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71DDEA4-C907-424A-A94D-2559D4CD30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C34F484-AC15-4037-B02C-5C2BD4ABD3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98A39-229D-4D69-9BDF-E34593257F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77983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F78A01D-D448-4C54-8E59-748704E01F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CBCC382B-3260-477C-822E-5F89450FE90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2C6CF82-0892-4E43-9DCB-DF6BD32FD11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9FA2E57-4BAA-4F07-9E03-F655D29FD0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9CED3E-DBD8-4918-938D-27755D3C3BD0}" type="datetimeFigureOut">
              <a:rPr kumimoji="1" lang="ja-JP" altLang="en-US" smtClean="0"/>
              <a:t>2023/7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0FAD5D5-0759-4CC4-BC21-AB77DBA9E2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035B1A5-084A-4070-A360-8DAF391B52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98A39-229D-4D69-9BDF-E34593257F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33554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3C251D18-A049-4EDF-8E6C-155172CD94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559B993-9D0D-46B8-A4E1-2016845D45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90CAB67-64B3-4B13-B189-2EC6E1951A1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9CED3E-DBD8-4918-938D-27755D3C3BD0}" type="datetimeFigureOut">
              <a:rPr kumimoji="1" lang="ja-JP" altLang="en-US" smtClean="0"/>
              <a:t>2023/7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0077E52-F3D1-465D-956B-63EDEF57D3E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6D82A03-A4A8-420C-846D-7F2C5BFD955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998A39-229D-4D69-9BDF-E34593257F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59703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sv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BAB95EBA-1177-4821-8B26-206CDD4DAE7C}"/>
              </a:ext>
            </a:extLst>
          </p:cNvPr>
          <p:cNvSpPr txBox="1"/>
          <p:nvPr/>
        </p:nvSpPr>
        <p:spPr>
          <a:xfrm>
            <a:off x="95693" y="159486"/>
            <a:ext cx="1044117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</a:t>
            </a:r>
            <a:r>
              <a:rPr lang="en-US" altLang="ja-JP" sz="20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2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udy design</a:t>
            </a:r>
            <a:endParaRPr lang="en-US" altLang="ja-JP" sz="2000" b="1" dirty="0">
              <a:solidFill>
                <a:prstClr val="black"/>
              </a:solidFill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2" name="矢印: 左右 1">
            <a:extLst>
              <a:ext uri="{FF2B5EF4-FFF2-40B4-BE49-F238E27FC236}">
                <a16:creationId xmlns:a16="http://schemas.microsoft.com/office/drawing/2014/main" id="{D34A90C5-EEED-E11D-C1A3-6F4BA017129E}"/>
              </a:ext>
            </a:extLst>
          </p:cNvPr>
          <p:cNvSpPr/>
          <p:nvPr/>
        </p:nvSpPr>
        <p:spPr>
          <a:xfrm>
            <a:off x="1266977" y="3155856"/>
            <a:ext cx="3210650" cy="588597"/>
          </a:xfrm>
          <a:prstGeom prst="leftRightArrow">
            <a:avLst>
              <a:gd name="adj1" fmla="val 36238"/>
              <a:gd name="adj2" fmla="val 72018"/>
            </a:avLst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7225FE6-7265-1BB9-A832-D15AF668A0BF}"/>
              </a:ext>
            </a:extLst>
          </p:cNvPr>
          <p:cNvSpPr txBox="1"/>
          <p:nvPr/>
        </p:nvSpPr>
        <p:spPr>
          <a:xfrm>
            <a:off x="3513102" y="1827412"/>
            <a:ext cx="2185665" cy="523220"/>
          </a:xfrm>
          <a:prstGeom prst="rect">
            <a:avLst/>
          </a:prstGeom>
          <a:solidFill>
            <a:srgbClr val="C00000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GLT2 Inhibitors or DPP4 Inhibitors User</a:t>
            </a:r>
            <a:endParaRPr lang="ja-JP" altLang="en-US" sz="14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矢印: 右 5">
            <a:extLst>
              <a:ext uri="{FF2B5EF4-FFF2-40B4-BE49-F238E27FC236}">
                <a16:creationId xmlns:a16="http://schemas.microsoft.com/office/drawing/2014/main" id="{5128D70A-EA77-3351-F6B2-26CC148EACCE}"/>
              </a:ext>
            </a:extLst>
          </p:cNvPr>
          <p:cNvSpPr/>
          <p:nvPr/>
        </p:nvSpPr>
        <p:spPr>
          <a:xfrm>
            <a:off x="4553264" y="3028865"/>
            <a:ext cx="6461398" cy="843280"/>
          </a:xfrm>
          <a:prstGeom prst="rightArrow">
            <a:avLst/>
          </a:prstGeom>
          <a:gradFill flip="none" rotWithShape="1">
            <a:gsLst>
              <a:gs pos="29000">
                <a:srgbClr val="C00000"/>
              </a:gs>
              <a:gs pos="63000">
                <a:srgbClr val="FF0000"/>
              </a:gs>
            </a:gsLst>
            <a:lin ang="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矢印: 右 6">
            <a:extLst>
              <a:ext uri="{FF2B5EF4-FFF2-40B4-BE49-F238E27FC236}">
                <a16:creationId xmlns:a16="http://schemas.microsoft.com/office/drawing/2014/main" id="{2A4B89A3-0D6A-3DC7-FBF8-F375C09DF349}"/>
              </a:ext>
            </a:extLst>
          </p:cNvPr>
          <p:cNvSpPr/>
          <p:nvPr/>
        </p:nvSpPr>
        <p:spPr>
          <a:xfrm rot="16200000">
            <a:off x="1221260" y="4064277"/>
            <a:ext cx="461433" cy="369996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矢印: 右 7">
            <a:extLst>
              <a:ext uri="{FF2B5EF4-FFF2-40B4-BE49-F238E27FC236}">
                <a16:creationId xmlns:a16="http://schemas.microsoft.com/office/drawing/2014/main" id="{18C0E63C-F8E8-8EC1-C8DA-D965924BC6C0}"/>
              </a:ext>
            </a:extLst>
          </p:cNvPr>
          <p:cNvSpPr/>
          <p:nvPr/>
        </p:nvSpPr>
        <p:spPr>
          <a:xfrm rot="16200000">
            <a:off x="4283080" y="4064277"/>
            <a:ext cx="461433" cy="369996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41D712DD-F4D1-FCE9-F3B5-C3F932EA0FDF}"/>
              </a:ext>
            </a:extLst>
          </p:cNvPr>
          <p:cNvSpPr txBox="1"/>
          <p:nvPr/>
        </p:nvSpPr>
        <p:spPr>
          <a:xfrm>
            <a:off x="6725434" y="3286457"/>
            <a:ext cx="256510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bservation Period</a:t>
            </a:r>
            <a:endParaRPr lang="ja-JP" altLang="en-US" sz="14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660A77CA-AA98-E39C-5AB5-B80CD1F2B0D8}"/>
              </a:ext>
            </a:extLst>
          </p:cNvPr>
          <p:cNvSpPr txBox="1"/>
          <p:nvPr/>
        </p:nvSpPr>
        <p:spPr>
          <a:xfrm>
            <a:off x="2081194" y="3296617"/>
            <a:ext cx="1631528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ook-Back Period</a:t>
            </a:r>
            <a:endParaRPr lang="ja-JP" altLang="en-US" sz="14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811B33C9-A27C-778B-DD1D-0EBF6327E038}"/>
              </a:ext>
            </a:extLst>
          </p:cNvPr>
          <p:cNvSpPr txBox="1"/>
          <p:nvPr/>
        </p:nvSpPr>
        <p:spPr>
          <a:xfrm>
            <a:off x="3414094" y="4524588"/>
            <a:ext cx="221928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scription</a:t>
            </a:r>
          </a:p>
          <a:p>
            <a:pPr algn="ctr"/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e</a:t>
            </a:r>
            <a:endParaRPr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C567BC70-1905-58FA-76AC-20C8BC3EEF30}"/>
              </a:ext>
            </a:extLst>
          </p:cNvPr>
          <p:cNvSpPr txBox="1"/>
          <p:nvPr/>
        </p:nvSpPr>
        <p:spPr>
          <a:xfrm>
            <a:off x="2209025" y="3669038"/>
            <a:ext cx="19257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t least 1 year)</a:t>
            </a:r>
            <a:endParaRPr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494A8096-9728-D6CC-B6A5-1A9F431358F6}"/>
              </a:ext>
            </a:extLst>
          </p:cNvPr>
          <p:cNvSpPr txBox="1"/>
          <p:nvPr/>
        </p:nvSpPr>
        <p:spPr>
          <a:xfrm>
            <a:off x="644530" y="4524589"/>
            <a:ext cx="1614887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surance</a:t>
            </a:r>
          </a:p>
          <a:p>
            <a:pPr algn="ctr"/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verage</a:t>
            </a:r>
            <a:endParaRPr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2BE29C34-419F-AE04-5473-D81E44EF9E4B}"/>
              </a:ext>
            </a:extLst>
          </p:cNvPr>
          <p:cNvSpPr txBox="1"/>
          <p:nvPr/>
        </p:nvSpPr>
        <p:spPr>
          <a:xfrm>
            <a:off x="6470406" y="3976815"/>
            <a:ext cx="3075157" cy="2062103"/>
          </a:xfrm>
          <a:prstGeom prst="rect">
            <a:avLst/>
          </a:prstGeom>
          <a:noFill/>
          <a:ln w="28575">
            <a:solidFill>
              <a:srgbClr val="C00000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6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Outcome</a:t>
            </a:r>
          </a:p>
          <a:p>
            <a:pPr marL="285750" indent="-285750">
              <a:buFont typeface="Wingdings" panose="05000000000000000000" pitchFamily="2" charset="2"/>
              <a:buChar char="ü"/>
            </a:pPr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atty Liver Index</a:t>
            </a:r>
          </a:p>
          <a:p>
            <a:pPr marL="285750" indent="-285750">
              <a:buFont typeface="Wingdings" panose="05000000000000000000" pitchFamily="2" charset="2"/>
              <a:buChar char="ü"/>
            </a:pPr>
            <a:r>
              <a:rPr lang="el-GR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γ-</a:t>
            </a: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Glutamyl Transpeptidase </a:t>
            </a:r>
          </a:p>
          <a:p>
            <a:pPr marL="285750" indent="-285750">
              <a:buFont typeface="Wingdings" panose="05000000000000000000" pitchFamily="2" charset="2"/>
              <a:buChar char="ü"/>
            </a:pP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spartate Aminotransferase </a:t>
            </a:r>
          </a:p>
          <a:p>
            <a:pPr marL="285750" indent="-285750">
              <a:buFont typeface="Wingdings" panose="05000000000000000000" pitchFamily="2" charset="2"/>
              <a:buChar char="ü"/>
            </a:pPr>
            <a:r>
              <a:rPr kumimoji="1" lang="en-US" altLang="ja-JP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</a:t>
            </a:r>
            <a:r>
              <a:rPr lang="en-US" altLang="ja-JP" sz="1600" b="1" dirty="0" err="1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lanine</a:t>
            </a: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Aminotransferase </a:t>
            </a:r>
          </a:p>
          <a:p>
            <a:pPr marL="285750" indent="-285750">
              <a:buFont typeface="Wingdings" panose="05000000000000000000" pitchFamily="2" charset="2"/>
              <a:buChar char="ü"/>
            </a:pPr>
            <a:r>
              <a:rPr kumimoji="1" lang="en-US" altLang="ja-JP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Body Mass Index</a:t>
            </a:r>
          </a:p>
          <a:p>
            <a:pPr marL="285750" indent="-285750">
              <a:buFont typeface="Wingdings" panose="05000000000000000000" pitchFamily="2" charset="2"/>
              <a:buChar char="ü"/>
            </a:pPr>
            <a:r>
              <a:rPr kumimoji="1" lang="en-US" altLang="ja-JP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Waist Circumference</a:t>
            </a:r>
          </a:p>
          <a:p>
            <a:pPr marL="285750" indent="-285750">
              <a:buFont typeface="Wingdings" panose="05000000000000000000" pitchFamily="2" charset="2"/>
              <a:buChar char="ü"/>
            </a:pPr>
            <a:r>
              <a:rPr kumimoji="1" lang="en-US" altLang="ja-JP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Hemoglobin A1c</a:t>
            </a:r>
            <a:endParaRPr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6" name="グラフィックス 15" descr="グループ">
            <a:extLst>
              <a:ext uri="{FF2B5EF4-FFF2-40B4-BE49-F238E27FC236}">
                <a16:creationId xmlns:a16="http://schemas.microsoft.com/office/drawing/2014/main" id="{A492497F-2F9D-C0AE-C97E-A9E4A11BB972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rcRect l="7122" t="17520" r="4218" b="21539"/>
          <a:stretch/>
        </p:blipFill>
        <p:spPr>
          <a:xfrm flipH="1">
            <a:off x="3978151" y="2434080"/>
            <a:ext cx="1038286" cy="713655"/>
          </a:xfrm>
          <a:prstGeom prst="rect">
            <a:avLst/>
          </a:prstGeom>
        </p:spPr>
      </p:pic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A9294521-1506-20AE-8B7F-540D5050BC23}"/>
              </a:ext>
            </a:extLst>
          </p:cNvPr>
          <p:cNvSpPr txBox="1"/>
          <p:nvPr/>
        </p:nvSpPr>
        <p:spPr>
          <a:xfrm>
            <a:off x="7760130" y="1541786"/>
            <a:ext cx="30868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GLT2 Inhibitors </a:t>
            </a:r>
            <a:endParaRPr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3" name="グラフィックス 22" descr="男性と女性">
            <a:extLst>
              <a:ext uri="{FF2B5EF4-FFF2-40B4-BE49-F238E27FC236}">
                <a16:creationId xmlns:a16="http://schemas.microsoft.com/office/drawing/2014/main" id="{F4D05D01-3119-8E4A-7726-0096C5AA7DF0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6978536" y="1313142"/>
            <a:ext cx="796434" cy="796434"/>
          </a:xfrm>
          <a:prstGeom prst="rect">
            <a:avLst/>
          </a:prstGeom>
        </p:spPr>
      </p:pic>
      <p:cxnSp>
        <p:nvCxnSpPr>
          <p:cNvPr id="24" name="直線矢印コネクタ 23">
            <a:extLst>
              <a:ext uri="{FF2B5EF4-FFF2-40B4-BE49-F238E27FC236}">
                <a16:creationId xmlns:a16="http://schemas.microsoft.com/office/drawing/2014/main" id="{FFA86210-2233-4D04-5515-78F647C50F89}"/>
              </a:ext>
            </a:extLst>
          </p:cNvPr>
          <p:cNvCxnSpPr>
            <a:cxnSpLocks/>
            <a:endCxn id="28" idx="1"/>
          </p:cNvCxnSpPr>
          <p:nvPr/>
        </p:nvCxnSpPr>
        <p:spPr>
          <a:xfrm>
            <a:off x="5213465" y="2781706"/>
            <a:ext cx="1765071" cy="0"/>
          </a:xfrm>
          <a:prstGeom prst="straightConnector1">
            <a:avLst/>
          </a:prstGeom>
          <a:ln w="25400">
            <a:solidFill>
              <a:srgbClr val="C00000"/>
            </a:solidFill>
            <a:headEnd type="none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矢印コネクタ 25">
            <a:extLst>
              <a:ext uri="{FF2B5EF4-FFF2-40B4-BE49-F238E27FC236}">
                <a16:creationId xmlns:a16="http://schemas.microsoft.com/office/drawing/2014/main" id="{9C205773-D5A3-986B-F23E-3FA1CAEA7A89}"/>
              </a:ext>
            </a:extLst>
          </p:cNvPr>
          <p:cNvCxnSpPr>
            <a:cxnSpLocks/>
          </p:cNvCxnSpPr>
          <p:nvPr/>
        </p:nvCxnSpPr>
        <p:spPr>
          <a:xfrm flipV="1">
            <a:off x="6110115" y="1740328"/>
            <a:ext cx="868421" cy="1033638"/>
          </a:xfrm>
          <a:prstGeom prst="straightConnector1">
            <a:avLst/>
          </a:prstGeom>
          <a:ln w="25400">
            <a:solidFill>
              <a:srgbClr val="C00000"/>
            </a:solidFill>
            <a:headEnd type="none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3418B62B-052C-8BC9-64B0-8DB7DAEFF995}"/>
              </a:ext>
            </a:extLst>
          </p:cNvPr>
          <p:cNvSpPr txBox="1"/>
          <p:nvPr/>
        </p:nvSpPr>
        <p:spPr>
          <a:xfrm>
            <a:off x="7760130" y="2612133"/>
            <a:ext cx="30868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PP4 Inhibitors</a:t>
            </a:r>
            <a:endParaRPr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8" name="グラフィックス 40" descr="男性と女性">
            <a:extLst>
              <a:ext uri="{FF2B5EF4-FFF2-40B4-BE49-F238E27FC236}">
                <a16:creationId xmlns:a16="http://schemas.microsoft.com/office/drawing/2014/main" id="{96C82550-F540-4CE4-8942-505A422A10AD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6978536" y="2383489"/>
            <a:ext cx="796434" cy="796434"/>
          </a:xfrm>
          <a:prstGeom prst="rect">
            <a:avLst/>
          </a:prstGeom>
        </p:spPr>
      </p:pic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id="{1BE94A06-7891-E418-31EC-74F639313D57}"/>
              </a:ext>
            </a:extLst>
          </p:cNvPr>
          <p:cNvSpPr/>
          <p:nvPr/>
        </p:nvSpPr>
        <p:spPr>
          <a:xfrm>
            <a:off x="4487311" y="3243883"/>
            <a:ext cx="58382" cy="411276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26947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74BF14B7-E342-4274-BD47-E9A6E85271EA}"/>
              </a:ext>
            </a:extLst>
          </p:cNvPr>
          <p:cNvSpPr txBox="1"/>
          <p:nvPr/>
        </p:nvSpPr>
        <p:spPr>
          <a:xfrm>
            <a:off x="440774" y="943058"/>
            <a:ext cx="8010499" cy="92333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ividuals newly taking the sodium-glucose cotransporter 2 inhibitor or </a:t>
            </a:r>
          </a:p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peptidyl peptidase-4 inhibitor with diabetes mellitus and metabolic dysfunction-associated fatty liver disease (n=21,883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71C057F8-E1CC-49D8-A666-893AE34BBC49}"/>
              </a:ext>
            </a:extLst>
          </p:cNvPr>
          <p:cNvSpPr txBox="1"/>
          <p:nvPr/>
        </p:nvSpPr>
        <p:spPr>
          <a:xfrm>
            <a:off x="454949" y="4786403"/>
            <a:ext cx="7996319" cy="36933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zed in this study (n=19,525)</a:t>
            </a:r>
            <a:endParaRPr kumimoji="1" lang="ja-JP" altLang="en-US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5" name="直線矢印コネクタ 34">
            <a:extLst>
              <a:ext uri="{FF2B5EF4-FFF2-40B4-BE49-F238E27FC236}">
                <a16:creationId xmlns:a16="http://schemas.microsoft.com/office/drawing/2014/main" id="{09586611-283A-4A51-BB5C-230AA274350C}"/>
              </a:ext>
            </a:extLst>
          </p:cNvPr>
          <p:cNvCxnSpPr>
            <a:cxnSpLocks/>
          </p:cNvCxnSpPr>
          <p:nvPr/>
        </p:nvCxnSpPr>
        <p:spPr>
          <a:xfrm>
            <a:off x="4153468" y="1877620"/>
            <a:ext cx="0" cy="2908783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直線矢印コネクタ 35">
            <a:extLst>
              <a:ext uri="{FF2B5EF4-FFF2-40B4-BE49-F238E27FC236}">
                <a16:creationId xmlns:a16="http://schemas.microsoft.com/office/drawing/2014/main" id="{01216011-B1E2-45BD-980E-BA379B73410E}"/>
              </a:ext>
            </a:extLst>
          </p:cNvPr>
          <p:cNvCxnSpPr/>
          <p:nvPr/>
        </p:nvCxnSpPr>
        <p:spPr>
          <a:xfrm>
            <a:off x="4156852" y="2807811"/>
            <a:ext cx="887819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D337FBA6-EE80-41CE-A6CE-D5E944A54667}"/>
              </a:ext>
            </a:extLst>
          </p:cNvPr>
          <p:cNvSpPr txBox="1"/>
          <p:nvPr/>
        </p:nvSpPr>
        <p:spPr>
          <a:xfrm>
            <a:off x="5044683" y="2611408"/>
            <a:ext cx="6756755" cy="369321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or history of liver disease (n=317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0" name="直線矢印コネクタ 39">
            <a:extLst>
              <a:ext uri="{FF2B5EF4-FFF2-40B4-BE49-F238E27FC236}">
                <a16:creationId xmlns:a16="http://schemas.microsoft.com/office/drawing/2014/main" id="{1BDF37A4-8E3F-4446-ADE8-FB71A90D134E}"/>
              </a:ext>
            </a:extLst>
          </p:cNvPr>
          <p:cNvCxnSpPr/>
          <p:nvPr/>
        </p:nvCxnSpPr>
        <p:spPr>
          <a:xfrm>
            <a:off x="4156845" y="3879519"/>
            <a:ext cx="887819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直線矢印コネクタ 40">
            <a:extLst>
              <a:ext uri="{FF2B5EF4-FFF2-40B4-BE49-F238E27FC236}">
                <a16:creationId xmlns:a16="http://schemas.microsoft.com/office/drawing/2014/main" id="{07E85CE3-185C-4BFB-9614-DD5EE0076DEE}"/>
              </a:ext>
            </a:extLst>
          </p:cNvPr>
          <p:cNvCxnSpPr/>
          <p:nvPr/>
        </p:nvCxnSpPr>
        <p:spPr>
          <a:xfrm>
            <a:off x="4153302" y="3328645"/>
            <a:ext cx="887819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6A945BA4-A7EE-49E2-AD08-DEC257AEDF7A}"/>
              </a:ext>
            </a:extLst>
          </p:cNvPr>
          <p:cNvSpPr txBox="1"/>
          <p:nvPr/>
        </p:nvSpPr>
        <p:spPr>
          <a:xfrm>
            <a:off x="5041133" y="3132242"/>
            <a:ext cx="6756755" cy="36933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ssing data on cigarette smoking (n=262)</a:t>
            </a: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29FF43D9-AC95-431C-B389-EA6B6ABCC7BB}"/>
              </a:ext>
            </a:extLst>
          </p:cNvPr>
          <p:cNvSpPr txBox="1"/>
          <p:nvPr/>
        </p:nvSpPr>
        <p:spPr>
          <a:xfrm>
            <a:off x="5045754" y="3681801"/>
            <a:ext cx="6756755" cy="36933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ssing data on alcohol consumption (n=1,257)</a:t>
            </a:r>
          </a:p>
        </p:txBody>
      </p:sp>
      <p:cxnSp>
        <p:nvCxnSpPr>
          <p:cNvPr id="45" name="直線矢印コネクタ 44">
            <a:extLst>
              <a:ext uri="{FF2B5EF4-FFF2-40B4-BE49-F238E27FC236}">
                <a16:creationId xmlns:a16="http://schemas.microsoft.com/office/drawing/2014/main" id="{761F5E4B-1E12-40DB-9F2C-2B7CD43ECB8B}"/>
              </a:ext>
            </a:extLst>
          </p:cNvPr>
          <p:cNvCxnSpPr/>
          <p:nvPr/>
        </p:nvCxnSpPr>
        <p:spPr>
          <a:xfrm>
            <a:off x="4156852" y="2267796"/>
            <a:ext cx="887819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F2A4DB8A-D34B-4C22-B3CA-83FADF7EF1A5}"/>
              </a:ext>
            </a:extLst>
          </p:cNvPr>
          <p:cNvSpPr txBox="1"/>
          <p:nvPr/>
        </p:nvSpPr>
        <p:spPr>
          <a:xfrm>
            <a:off x="5044683" y="2071393"/>
            <a:ext cx="6756755" cy="369321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ed &lt; 20 years (n=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BAB95EBA-1177-4821-8B26-206CDD4DAE7C}"/>
              </a:ext>
            </a:extLst>
          </p:cNvPr>
          <p:cNvSpPr txBox="1"/>
          <p:nvPr/>
        </p:nvSpPr>
        <p:spPr>
          <a:xfrm>
            <a:off x="95693" y="159486"/>
            <a:ext cx="1044117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</a:t>
            </a:r>
            <a:r>
              <a:rPr lang="en-US" altLang="ja-JP" sz="20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2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lowchart</a:t>
            </a:r>
            <a:endParaRPr lang="en-US" altLang="ja-JP" sz="2000" b="1" dirty="0">
              <a:solidFill>
                <a:prstClr val="black"/>
              </a:solidFill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3" name="直線矢印コネクタ 2">
            <a:extLst>
              <a:ext uri="{FF2B5EF4-FFF2-40B4-BE49-F238E27FC236}">
                <a16:creationId xmlns:a16="http://schemas.microsoft.com/office/drawing/2014/main" id="{43B8135C-93C4-91D6-891B-1DF73CBC81B8}"/>
              </a:ext>
            </a:extLst>
          </p:cNvPr>
          <p:cNvCxnSpPr/>
          <p:nvPr/>
        </p:nvCxnSpPr>
        <p:spPr>
          <a:xfrm>
            <a:off x="4156845" y="4391096"/>
            <a:ext cx="887819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F179463-7CC5-947B-510C-E6B9D6723FAF}"/>
              </a:ext>
            </a:extLst>
          </p:cNvPr>
          <p:cNvSpPr txBox="1"/>
          <p:nvPr/>
        </p:nvSpPr>
        <p:spPr>
          <a:xfrm>
            <a:off x="5045754" y="4193378"/>
            <a:ext cx="6756755" cy="36933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ssing data on physical activity (n=521)</a:t>
            </a:r>
          </a:p>
        </p:txBody>
      </p:sp>
    </p:spTree>
    <p:extLst>
      <p:ext uri="{BB962C8B-B14F-4D97-AF65-F5344CB8AC3E}">
        <p14:creationId xmlns:p14="http://schemas.microsoft.com/office/powerpoint/2010/main" val="30250745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図 7">
            <a:extLst>
              <a:ext uri="{FF2B5EF4-FFF2-40B4-BE49-F238E27FC236}">
                <a16:creationId xmlns:a16="http://schemas.microsoft.com/office/drawing/2014/main" id="{0458B241-367B-43FC-121E-0A80291871C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29200" y="1591200"/>
            <a:ext cx="4982384" cy="3625200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9DCA6A6-88CD-C712-C044-A09F889EF239}"/>
              </a:ext>
            </a:extLst>
          </p:cNvPr>
          <p:cNvSpPr txBox="1"/>
          <p:nvPr/>
        </p:nvSpPr>
        <p:spPr>
          <a:xfrm rot="16200000">
            <a:off x="1523827" y="3068886"/>
            <a:ext cx="31330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Fatty Liver Index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E58C6429-3B94-44BA-F96C-B41C2AF776E3}"/>
              </a:ext>
            </a:extLst>
          </p:cNvPr>
          <p:cNvSpPr txBox="1"/>
          <p:nvPr/>
        </p:nvSpPr>
        <p:spPr>
          <a:xfrm>
            <a:off x="5004429" y="5119300"/>
            <a:ext cx="18017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Years after Enrollment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766C223-2346-117D-4DEA-DA48E15AB7F1}"/>
              </a:ext>
            </a:extLst>
          </p:cNvPr>
          <p:cNvSpPr txBox="1"/>
          <p:nvPr/>
        </p:nvSpPr>
        <p:spPr>
          <a:xfrm>
            <a:off x="67986" y="159486"/>
            <a:ext cx="1178684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</a:t>
            </a:r>
            <a:r>
              <a:rPr lang="en-US" altLang="ja-JP" sz="20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Comparison of the Change in Fatty Liver Index (Continuous Prescription Group)</a:t>
            </a: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4D02C3D-FEA4-4F6B-850A-12FEB60957A1}"/>
              </a:ext>
            </a:extLst>
          </p:cNvPr>
          <p:cNvSpPr txBox="1"/>
          <p:nvPr/>
        </p:nvSpPr>
        <p:spPr>
          <a:xfrm>
            <a:off x="3767359" y="1526628"/>
            <a:ext cx="20591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 for interaction &lt;0.001</a:t>
            </a:r>
            <a:endParaRPr lang="ja-JP" altLang="en-US" sz="12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4592432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id="{69DC1941-1D3F-800A-8972-E715C3A0842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29200" y="1591200"/>
            <a:ext cx="4982384" cy="3625200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9DCA6A6-88CD-C712-C044-A09F889EF239}"/>
              </a:ext>
            </a:extLst>
          </p:cNvPr>
          <p:cNvSpPr txBox="1"/>
          <p:nvPr/>
        </p:nvSpPr>
        <p:spPr>
          <a:xfrm rot="16200000">
            <a:off x="1523827" y="3068886"/>
            <a:ext cx="31330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Fatty Liver Index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E58C6429-3B94-44BA-F96C-B41C2AF776E3}"/>
              </a:ext>
            </a:extLst>
          </p:cNvPr>
          <p:cNvSpPr txBox="1"/>
          <p:nvPr/>
        </p:nvSpPr>
        <p:spPr>
          <a:xfrm>
            <a:off x="5004429" y="5119300"/>
            <a:ext cx="18017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Years after Enrollment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766C223-2346-117D-4DEA-DA48E15AB7F1}"/>
              </a:ext>
            </a:extLst>
          </p:cNvPr>
          <p:cNvSpPr txBox="1"/>
          <p:nvPr/>
        </p:nvSpPr>
        <p:spPr>
          <a:xfrm>
            <a:off x="67986" y="159486"/>
            <a:ext cx="1178684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.</a:t>
            </a:r>
            <a:r>
              <a:rPr lang="en-US" altLang="ja-JP" sz="2000" b="1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Comparison of the Change in Outcomes (Cubic Spline Function)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57727BDF-CBA7-0088-2F81-F3F21B7286CD}"/>
              </a:ext>
            </a:extLst>
          </p:cNvPr>
          <p:cNvSpPr txBox="1"/>
          <p:nvPr/>
        </p:nvSpPr>
        <p:spPr>
          <a:xfrm>
            <a:off x="3767359" y="1526628"/>
            <a:ext cx="20591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 for interaction &lt;0.001</a:t>
            </a:r>
            <a:endParaRPr lang="ja-JP" altLang="en-US" sz="12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896395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627</TotalTime>
  <Words>191</Words>
  <Application>Microsoft Office PowerPoint</Application>
  <PresentationFormat>ワイド画面</PresentationFormat>
  <Paragraphs>36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0" baseType="lpstr">
      <vt:lpstr>游ゴシック</vt:lpstr>
      <vt:lpstr>游ゴシック Light</vt:lpstr>
      <vt:lpstr>Arial</vt:lpstr>
      <vt:lpstr>Times New Roman</vt:lpstr>
      <vt:lpstr>Wingdings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裕太 鈴木</dc:creator>
  <cp:lastModifiedBy>C2H</cp:lastModifiedBy>
  <cp:revision>71</cp:revision>
  <dcterms:created xsi:type="dcterms:W3CDTF">2022-03-22T08:45:25Z</dcterms:created>
  <dcterms:modified xsi:type="dcterms:W3CDTF">2023-07-22T00:51:11Z</dcterms:modified>
</cp:coreProperties>
</file>